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106" d="100"/>
          <a:sy n="106" d="100"/>
        </p:scale>
        <p:origin x="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/>
              <a:t>Missouri SCI T-Scores by Gender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ather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1]Graphs-1'!$D$143:$D$148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G$143:$G$148</c:f>
              <c:numCache>
                <c:formatCode>0%</c:formatCode>
                <c:ptCount val="6"/>
                <c:pt idx="0">
                  <c:v>2.1052631578947368E-2</c:v>
                </c:pt>
                <c:pt idx="1">
                  <c:v>0.5368421052631579</c:v>
                </c:pt>
                <c:pt idx="2">
                  <c:v>0.30526315789473685</c:v>
                </c:pt>
                <c:pt idx="3">
                  <c:v>0.12631578947368421</c:v>
                </c:pt>
                <c:pt idx="4">
                  <c:v>1.0526315789473684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E9-4044-9B8A-3235ED083E49}"/>
            </c:ext>
          </c:extLst>
        </c:ser>
        <c:ser>
          <c:idx val="1"/>
          <c:order val="1"/>
          <c:tx>
            <c:v>Mother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1]Graphs-1'!$D$143:$D$148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H$143:$H$148</c:f>
              <c:numCache>
                <c:formatCode>0%</c:formatCode>
                <c:ptCount val="6"/>
                <c:pt idx="0">
                  <c:v>0</c:v>
                </c:pt>
                <c:pt idx="1">
                  <c:v>0.70526315789473681</c:v>
                </c:pt>
                <c:pt idx="2">
                  <c:v>0.24210526315789474</c:v>
                </c:pt>
                <c:pt idx="3">
                  <c:v>3.1578947368421054E-2</c:v>
                </c:pt>
                <c:pt idx="4">
                  <c:v>2.1052631578947368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6E9-4044-9B8A-3235ED083E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6021664"/>
        <c:axId val="896026344"/>
      </c:barChart>
      <c:catAx>
        <c:axId val="896021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96026344"/>
        <c:crosses val="autoZero"/>
        <c:auto val="1"/>
        <c:lblAlgn val="ctr"/>
        <c:lblOffset val="100"/>
        <c:noMultiLvlLbl val="0"/>
      </c:catAx>
      <c:valAx>
        <c:axId val="8960263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</a:t>
                </a:r>
                <a:r>
                  <a:rPr lang="en-US" baseline="0"/>
                  <a:t> of parent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960216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/>
              <a:t>California SCI T-Scores by Gender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ather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1]Graphs-1'!$D$162:$D$167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G$162:$G$167</c:f>
              <c:numCache>
                <c:formatCode>0%</c:formatCode>
                <c:ptCount val="6"/>
                <c:pt idx="0">
                  <c:v>1.0752688172043012E-2</c:v>
                </c:pt>
                <c:pt idx="1">
                  <c:v>0.44086021505376344</c:v>
                </c:pt>
                <c:pt idx="2">
                  <c:v>0.39784946236559138</c:v>
                </c:pt>
                <c:pt idx="3">
                  <c:v>0.13978494623655913</c:v>
                </c:pt>
                <c:pt idx="4">
                  <c:v>1.0752688172043012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8C-487C-82E0-93FCDBFACCC2}"/>
            </c:ext>
          </c:extLst>
        </c:ser>
        <c:ser>
          <c:idx val="1"/>
          <c:order val="1"/>
          <c:tx>
            <c:v>Mother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1]Graphs-1'!$D$162:$D$167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H$162:$H$167</c:f>
              <c:numCache>
                <c:formatCode>0%</c:formatCode>
                <c:ptCount val="6"/>
                <c:pt idx="0">
                  <c:v>1.0752688172043012E-2</c:v>
                </c:pt>
                <c:pt idx="1">
                  <c:v>0.5376344086021505</c:v>
                </c:pt>
                <c:pt idx="2">
                  <c:v>0.34408602150537637</c:v>
                </c:pt>
                <c:pt idx="3">
                  <c:v>8.6021505376344093E-2</c:v>
                </c:pt>
                <c:pt idx="4">
                  <c:v>1.0752688172043012E-2</c:v>
                </c:pt>
                <c:pt idx="5">
                  <c:v>1.075268817204301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8C-487C-82E0-93FCDBFACC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4679096"/>
        <c:axId val="774678016"/>
      </c:barChart>
      <c:catAx>
        <c:axId val="774679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4678016"/>
        <c:crosses val="autoZero"/>
        <c:auto val="1"/>
        <c:lblAlgn val="ctr"/>
        <c:lblOffset val="100"/>
        <c:noMultiLvlLbl val="0"/>
      </c:catAx>
      <c:valAx>
        <c:axId val="774678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</a:t>
                </a:r>
                <a:r>
                  <a:rPr lang="en-US" baseline="0"/>
                  <a:t> of parent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4679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/>
              <a:t>Missouri RRB T-Scores by Gender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ather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1]Graphs-1'!$D$181:$D$186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G$181:$G$186</c:f>
              <c:numCache>
                <c:formatCode>0%</c:formatCode>
                <c:ptCount val="6"/>
                <c:pt idx="0">
                  <c:v>0</c:v>
                </c:pt>
                <c:pt idx="1">
                  <c:v>0.47368421052631576</c:v>
                </c:pt>
                <c:pt idx="2">
                  <c:v>0.44210526315789472</c:v>
                </c:pt>
                <c:pt idx="3">
                  <c:v>7.5268817204301078E-2</c:v>
                </c:pt>
                <c:pt idx="4">
                  <c:v>1.0752688172043012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59-48AF-9337-5CB0C6243612}"/>
            </c:ext>
          </c:extLst>
        </c:ser>
        <c:ser>
          <c:idx val="1"/>
          <c:order val="1"/>
          <c:tx>
            <c:v>Mother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1]Graphs-1'!$D$181:$D$186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H$181:$H$186</c:f>
              <c:numCache>
                <c:formatCode>0%</c:formatCode>
                <c:ptCount val="6"/>
                <c:pt idx="0">
                  <c:v>0</c:v>
                </c:pt>
                <c:pt idx="1">
                  <c:v>0.71578947368421053</c:v>
                </c:pt>
                <c:pt idx="2">
                  <c:v>0.25263157894736843</c:v>
                </c:pt>
                <c:pt idx="3">
                  <c:v>3.1578947368421054E-2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59-48AF-9337-5CB0C62436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63870744"/>
        <c:axId val="763865344"/>
      </c:barChart>
      <c:catAx>
        <c:axId val="763870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3865344"/>
        <c:crosses val="autoZero"/>
        <c:auto val="1"/>
        <c:lblAlgn val="ctr"/>
        <c:lblOffset val="100"/>
        <c:noMultiLvlLbl val="0"/>
      </c:catAx>
      <c:valAx>
        <c:axId val="7638653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</a:t>
                </a:r>
                <a:r>
                  <a:rPr lang="en-US" baseline="0"/>
                  <a:t> of parent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3870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/>
              <a:t>California RRB T-Scores by Gender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ather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1]Graphs-1'!$D$200:$D$205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G$200:$G$205</c:f>
              <c:numCache>
                <c:formatCode>0%</c:formatCode>
                <c:ptCount val="6"/>
                <c:pt idx="0">
                  <c:v>0</c:v>
                </c:pt>
                <c:pt idx="1">
                  <c:v>0.45161290322580644</c:v>
                </c:pt>
                <c:pt idx="2">
                  <c:v>0.44086021505376344</c:v>
                </c:pt>
                <c:pt idx="3">
                  <c:v>9.6774193548387094E-2</c:v>
                </c:pt>
                <c:pt idx="4">
                  <c:v>1.0752688172043012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F0-4F37-A15A-CFDA67551D59}"/>
            </c:ext>
          </c:extLst>
        </c:ser>
        <c:ser>
          <c:idx val="1"/>
          <c:order val="1"/>
          <c:tx>
            <c:v>Mother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1]Graphs-1'!$D$200:$D$205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1'!$H$200:$H$205</c:f>
              <c:numCache>
                <c:formatCode>0%</c:formatCode>
                <c:ptCount val="6"/>
                <c:pt idx="0">
                  <c:v>0</c:v>
                </c:pt>
                <c:pt idx="1">
                  <c:v>0.5268817204301075</c:v>
                </c:pt>
                <c:pt idx="2">
                  <c:v>0.40860215053763443</c:v>
                </c:pt>
                <c:pt idx="3">
                  <c:v>5.3763440860215055E-2</c:v>
                </c:pt>
                <c:pt idx="4">
                  <c:v>0</c:v>
                </c:pt>
                <c:pt idx="5">
                  <c:v>1.075268817204301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F0-4F37-A15A-CFDA67551D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62531720"/>
        <c:axId val="762532800"/>
      </c:barChart>
      <c:catAx>
        <c:axId val="762531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2532800"/>
        <c:crosses val="autoZero"/>
        <c:auto val="1"/>
        <c:lblAlgn val="ctr"/>
        <c:lblOffset val="100"/>
        <c:noMultiLvlLbl val="0"/>
      </c:catAx>
      <c:valAx>
        <c:axId val="762532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</a:t>
                </a:r>
                <a:r>
                  <a:rPr lang="en-US" baseline="0"/>
                  <a:t> of parent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25317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issouri SRS T-Scores by Gende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ather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1]Graphs-2'!$E$3:$E$8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2'!$H$3:$H$8</c:f>
              <c:numCache>
                <c:formatCode>0%</c:formatCode>
                <c:ptCount val="6"/>
                <c:pt idx="0">
                  <c:v>0</c:v>
                </c:pt>
                <c:pt idx="1">
                  <c:v>0.54736842105263162</c:v>
                </c:pt>
                <c:pt idx="2">
                  <c:v>0.33684210526315789</c:v>
                </c:pt>
                <c:pt idx="3">
                  <c:v>0.10526315789473684</c:v>
                </c:pt>
                <c:pt idx="4">
                  <c:v>1.0526315789473684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90-42B5-95DD-B0D0794D19E8}"/>
            </c:ext>
          </c:extLst>
        </c:ser>
        <c:ser>
          <c:idx val="1"/>
          <c:order val="1"/>
          <c:tx>
            <c:v>Mother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1]Graphs-2'!$E$3:$E$8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2'!$I$3:$I$8</c:f>
              <c:numCache>
                <c:formatCode>0%</c:formatCode>
                <c:ptCount val="6"/>
                <c:pt idx="0">
                  <c:v>0</c:v>
                </c:pt>
                <c:pt idx="1">
                  <c:v>0.70526315789473681</c:v>
                </c:pt>
                <c:pt idx="2">
                  <c:v>0.24210526315789474</c:v>
                </c:pt>
                <c:pt idx="3">
                  <c:v>3.1578947368421054E-2</c:v>
                </c:pt>
                <c:pt idx="4">
                  <c:v>2.1052631578947368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E90-42B5-95DD-B0D0794D19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4679816"/>
        <c:axId val="774680176"/>
      </c:barChart>
      <c:catAx>
        <c:axId val="774679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4680176"/>
        <c:crosses val="autoZero"/>
        <c:auto val="1"/>
        <c:lblAlgn val="ctr"/>
        <c:lblOffset val="100"/>
        <c:noMultiLvlLbl val="0"/>
      </c:catAx>
      <c:valAx>
        <c:axId val="774680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</a:t>
                </a:r>
                <a:r>
                  <a:rPr lang="en-US" baseline="0"/>
                  <a:t> of parent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46798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/>
              <a:t>California SRS T-Scores by Gender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ather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1]Graphs-2'!$E$26:$E$31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2'!$H$26:$H$31</c:f>
              <c:numCache>
                <c:formatCode>0%</c:formatCode>
                <c:ptCount val="6"/>
                <c:pt idx="0">
                  <c:v>0</c:v>
                </c:pt>
                <c:pt idx="1">
                  <c:v>0.4838709677419355</c:v>
                </c:pt>
                <c:pt idx="2">
                  <c:v>0.38709677419354838</c:v>
                </c:pt>
                <c:pt idx="3">
                  <c:v>0.11827956989247312</c:v>
                </c:pt>
                <c:pt idx="4">
                  <c:v>1.0752688172043012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E2-4EB1-97B9-9A6E5774668A}"/>
            </c:ext>
          </c:extLst>
        </c:ser>
        <c:ser>
          <c:idx val="1"/>
          <c:order val="1"/>
          <c:tx>
            <c:v>Mother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1]Graphs-2'!$E$26:$E$31</c:f>
              <c:strCache>
                <c:ptCount val="6"/>
                <c:pt idx="0">
                  <c:v>0-35</c:v>
                </c:pt>
                <c:pt idx="1">
                  <c:v>36-44</c:v>
                </c:pt>
                <c:pt idx="2">
                  <c:v>45-53</c:v>
                </c:pt>
                <c:pt idx="3">
                  <c:v>54-62</c:v>
                </c:pt>
                <c:pt idx="4">
                  <c:v>63-71</c:v>
                </c:pt>
                <c:pt idx="5">
                  <c:v>72-80</c:v>
                </c:pt>
              </c:strCache>
            </c:strRef>
          </c:cat>
          <c:val>
            <c:numRef>
              <c:f>'[1]Graphs-2'!$I$26:$I$31</c:f>
              <c:numCache>
                <c:formatCode>0%</c:formatCode>
                <c:ptCount val="6"/>
                <c:pt idx="0">
                  <c:v>0</c:v>
                </c:pt>
                <c:pt idx="1">
                  <c:v>0.55913978494623651</c:v>
                </c:pt>
                <c:pt idx="2">
                  <c:v>0.34408602150537637</c:v>
                </c:pt>
                <c:pt idx="3">
                  <c:v>7.5268817204301078E-2</c:v>
                </c:pt>
                <c:pt idx="4">
                  <c:v>1.0752688172043012E-2</c:v>
                </c:pt>
                <c:pt idx="5">
                  <c:v>1.075268817204301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1E2-4EB1-97B9-9A6E577466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08073992"/>
        <c:axId val="908074352"/>
      </c:barChart>
      <c:catAx>
        <c:axId val="908073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08074352"/>
        <c:crosses val="autoZero"/>
        <c:auto val="1"/>
        <c:lblAlgn val="ctr"/>
        <c:lblOffset val="100"/>
        <c:noMultiLvlLbl val="0"/>
      </c:catAx>
      <c:valAx>
        <c:axId val="908074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</a:t>
                </a:r>
                <a:r>
                  <a:rPr lang="en-US" baseline="0"/>
                  <a:t> of parent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080739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B6D4AD-C7F9-AC44-69B3-149729ED57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03B203A-3034-238D-137E-7020CAF9D1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2D8F06-CC5F-763B-437D-B29C5FD54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7DFAF1-6600-406F-7172-7CB5EEE57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865B02-397F-1320-DAAB-C1391F5E4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026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BBC80-24A6-9B23-757D-26D91C1B1C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32960A-BEEF-CC28-7657-A3F3DF5243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7925C6-A850-2505-64E0-8D9051462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207543-15B1-FD26-2C75-B3C3B7AAF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493FE4-FBA0-0B13-8596-79B7006D7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38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84E7D9-D5DF-EBE5-3101-C79574B0E2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C90E21-8145-B7A5-4BF4-2DCB616699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ED9623-6144-F9AA-92E8-9B2D04739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D64BF-F9E5-7813-32CB-A87670328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3865E9-49C5-587C-039B-5DD1AFF2A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708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0FA4A-4419-341C-18F0-6A3C32C672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68F8D7-5A19-2C79-0458-619EDA8DB5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A7C69-5D26-F6A3-E70D-F04493BB9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72EF42-FB4E-52D2-8FC9-18908F441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D8AEB-D454-DF28-48B3-4EC64F282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456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B36E2-369E-64AC-F8CC-0C943D1C2E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20451B-6038-FA14-1D82-169FBA2F76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A8AEBD-F8E0-3F3C-5A7C-CCCC21BEA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BEFBB0-186C-D030-69EC-CA5850F2E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86B114-38A4-6323-8DC5-66072F4CC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465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E0D25F-57B1-932E-35B2-74C2A5D1A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3381A2-DD5F-3125-FD76-6C1CB6B763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BCA10F-45E7-4DA1-E7C5-F3700FB5CC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F1DA10-C2FB-BD9E-23DB-5AD343FDC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2C6295-EFAC-B212-4DAB-C9BB3C3C2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7BCFDE-87E8-A512-B64D-A3C08D59D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032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4C3524-D044-E046-BB9F-CE6A73B59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841390-B1A9-1E09-BB86-F530A99BDC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DA38-C02F-6BA5-AC55-A8BBB5E4E4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C96542-68A6-546B-FBD2-F574C1DDDF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CF576F-C7DD-21B6-E4F5-670752D179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FFD5141-6D59-60F0-271E-6C0853F34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60A4E7-205E-79DB-74C2-CF0FB12FE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EE2CE2-E1BF-CB87-1DE0-6572F869F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84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B45099-A6E7-656B-7705-11FF55EBA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A9EACF-1CEB-D0AA-CB81-F4B5684CD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43D46C-07F9-E744-B1F0-3B76185E4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9B3F2C-654A-721F-FF3F-322051887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886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64C8C3-5736-6793-1D25-28CF2D717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ACF50F-6000-C6AF-9359-A35659FF4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D62024-4B1A-86D1-C3A2-CFCC34E89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08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F655A-5559-A832-E33D-3F699B67F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347996-4BE3-DC9D-50FF-464E161322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4D18FA-43EC-EBCC-223F-C75793F650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B8E2F-AC67-49EC-EBCA-B1D6CE0FB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86DE20-D460-30DF-DC06-179017988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073BF2-E9EF-C4DF-1D27-AD12A022A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262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825864-4A67-283F-67D5-0DA91B5B49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34F43C1-2338-72DE-A16D-9694C19EA7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127984-E9BD-8757-3BAF-12DD7CBE43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E0BC8B-B2C6-1E97-CABF-F4EBF1C4A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425203-D677-FD1F-4392-0FC53D1C3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D7E3A9-B4D1-CB87-46D0-A2B111787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839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CA6D0D-BA75-C21E-FDD1-16CC3AD794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821CD5-E070-76BF-F6DA-AF1A63751E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185745-C3BA-761A-2E32-E3EA8462CA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3FABB-A86C-4DAE-8DC0-4F9E14ED046C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CB0EA0-1396-99C1-397D-5A680364E7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4260BA-7DBB-15A4-94D5-C785012C8C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572801-4820-4383-A078-18B157BE85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173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1A8BA2E-5416-4E54-86B5-7AF13DD718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1363045"/>
              </p:ext>
            </p:extLst>
          </p:nvPr>
        </p:nvGraphicFramePr>
        <p:xfrm>
          <a:off x="4131715" y="811148"/>
          <a:ext cx="3928570" cy="29538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29F46453-A038-4CD8-80F0-BC42A31819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6044769"/>
              </p:ext>
            </p:extLst>
          </p:nvPr>
        </p:nvGraphicFramePr>
        <p:xfrm>
          <a:off x="4131715" y="3872210"/>
          <a:ext cx="3928570" cy="2985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5B52E973-F2B4-4182-A092-C2C25A6766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4634276"/>
              </p:ext>
            </p:extLst>
          </p:nvPr>
        </p:nvGraphicFramePr>
        <p:xfrm>
          <a:off x="8170949" y="811148"/>
          <a:ext cx="3928570" cy="29538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92A2342-B76B-47D3-8836-8EF8A6CF9D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3374070"/>
              </p:ext>
            </p:extLst>
          </p:nvPr>
        </p:nvGraphicFramePr>
        <p:xfrm>
          <a:off x="8170949" y="3872210"/>
          <a:ext cx="3928570" cy="29662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B7E3BB81-9A16-4425-9B5D-8CA0F5C55B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1631429"/>
              </p:ext>
            </p:extLst>
          </p:nvPr>
        </p:nvGraphicFramePr>
        <p:xfrm>
          <a:off x="92481" y="811148"/>
          <a:ext cx="3928570" cy="2953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F77FD561-EF1F-4707-B9CC-B8F2D4106A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3995229"/>
              </p:ext>
            </p:extLst>
          </p:nvPr>
        </p:nvGraphicFramePr>
        <p:xfrm>
          <a:off x="92481" y="3872210"/>
          <a:ext cx="3928570" cy="2985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TextBox 7">
            <a:extLst>
              <a:ext uri="{FF2B5EF4-FFF2-40B4-BE49-F238E27FC236}">
                <a16:creationId xmlns:a16="http://schemas.microsoft.com/office/drawing/2014/main" id="{1B2656E7-3949-4A8F-AB20-A52B408DC36D}"/>
              </a:ext>
            </a:extLst>
          </p:cNvPr>
          <p:cNvSpPr txBox="1"/>
          <p:nvPr/>
        </p:nvSpPr>
        <p:spPr>
          <a:xfrm>
            <a:off x="499906" y="222583"/>
            <a:ext cx="11192187" cy="461789"/>
          </a:xfrm>
          <a:prstGeom prst="rect">
            <a:avLst/>
          </a:prstGeom>
          <a:solidFill>
            <a:sysClr val="window" lastClr="FFFFFF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solidFill>
                  <a:sysClr val="windowText" lastClr="000000"/>
                </a:solidFill>
              </a:rPr>
              <a:t>Figure</a:t>
            </a:r>
            <a:r>
              <a:rPr lang="en-US" sz="2000" b="1" baseline="0" dirty="0">
                <a:solidFill>
                  <a:sysClr val="windowText" lastClr="000000"/>
                </a:solidFill>
              </a:rPr>
              <a:t> 1. SRS, SCI, and RRB T-Scores Among Hispanic (California) and Non-Hispanic (Missouri) Parents</a:t>
            </a:r>
            <a:r>
              <a:rPr lang="en-US" sz="2000" baseline="0" dirty="0">
                <a:solidFill>
                  <a:sysClr val="windowText" lastClr="000000"/>
                </a:solidFill>
              </a:rPr>
              <a:t>. </a:t>
            </a:r>
            <a:endParaRPr lang="en-US" sz="2000" dirty="0">
              <a:solidFill>
                <a:sysClr val="windowText" lastClr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3454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70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queline Joyce</dc:creator>
  <cp:lastModifiedBy>Jacqueline Joyce</cp:lastModifiedBy>
  <cp:revision>2</cp:revision>
  <dcterms:created xsi:type="dcterms:W3CDTF">2024-01-03T20:04:31Z</dcterms:created>
  <dcterms:modified xsi:type="dcterms:W3CDTF">2024-04-11T20:38:47Z</dcterms:modified>
</cp:coreProperties>
</file>